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FA3AC-34EA-409D-BC46-C422B3DCE5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066B3-6CA2-47F0-BBA4-9D748288C7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74AE6-8265-47BF-949C-D138862CC3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B7FC3-4352-4253-A7C0-8039408D31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A362F-9A7F-4FB0-B673-BAA80DE374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FF6DA-8B46-4BA2-8675-DC476F4202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AE3BB-73C5-4E7A-81B5-B8EF4ECE08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DD6F9-7F62-4614-90B7-85ADBEA77F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160A5-FD4F-461E-B60F-3BC190AD5F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0C1466-DAEE-4F26-A694-38B9E6376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C60FE-5A82-49AF-B51A-07CEFEA274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26CF5-227C-4D63-8E6B-C2DBA7579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386AB2-9C63-4F4F-B45B-F7F0A339CA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2984400" y="611280"/>
            <a:ext cx="8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920960" y="2503440"/>
            <a:ext cx="3016080" cy="4782960"/>
            <a:chOff x="1920960" y="2503440"/>
            <a:chExt cx="3016080" cy="4782960"/>
          </a:xfrm>
        </p:grpSpPr>
        <p:sp>
          <p:nvSpPr>
            <p:cNvPr id="43" name=""/>
            <p:cNvSpPr/>
            <p:nvPr/>
          </p:nvSpPr>
          <p:spPr>
            <a:xfrm rot="18750600">
              <a:off x="3611880" y="6684480"/>
              <a:ext cx="1285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Buds and open flower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440080" y="403560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40080" y="387684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440080" y="3720960"/>
              <a:ext cx="219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440080" y="356076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40080" y="340524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40080" y="324648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438280" y="3087720"/>
              <a:ext cx="223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325240" y="4125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225160" y="3967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25160" y="38098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225160" y="36511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225160" y="34941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225160" y="33354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25160" y="31798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728800" y="4235400"/>
              <a:ext cx="303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l-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511440" y="4235400"/>
              <a:ext cx="42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mda1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334040" y="4235400"/>
              <a:ext cx="4284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mda1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60600" y="3089160"/>
              <a:ext cx="2476440" cy="1103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460600" y="3089160"/>
              <a:ext cx="2476440" cy="11034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705040" y="3405240"/>
              <a:ext cx="331920" cy="7873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532320" y="3800520"/>
              <a:ext cx="328320" cy="39204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356000" y="3722760"/>
              <a:ext cx="330480" cy="4698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871720" y="327492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71720" y="327492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"/>
            <p:cNvGrpSpPr/>
            <p:nvPr/>
          </p:nvGrpSpPr>
          <p:grpSpPr>
            <a:xfrm>
              <a:off x="3681360" y="3742920"/>
              <a:ext cx="31680" cy="125640"/>
              <a:chOff x="3681360" y="3742920"/>
              <a:chExt cx="31680" cy="125640"/>
            </a:xfrm>
          </p:grpSpPr>
          <p:sp>
            <p:nvSpPr>
              <p:cNvPr id="69" name=""/>
              <p:cNvSpPr/>
              <p:nvPr/>
            </p:nvSpPr>
            <p:spPr>
              <a:xfrm flipV="1">
                <a:off x="3695760" y="3742920"/>
                <a:ext cx="0" cy="61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681360" y="3743280"/>
                <a:ext cx="31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695760" y="380484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681360" y="3868560"/>
                <a:ext cx="31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" name=""/>
            <p:cNvGrpSpPr/>
            <p:nvPr/>
          </p:nvGrpSpPr>
          <p:grpSpPr>
            <a:xfrm>
              <a:off x="4508640" y="3482640"/>
              <a:ext cx="29880" cy="520920"/>
              <a:chOff x="4508640" y="3482640"/>
              <a:chExt cx="29880" cy="520920"/>
            </a:xfrm>
          </p:grpSpPr>
          <p:sp>
            <p:nvSpPr>
              <p:cNvPr id="74" name=""/>
              <p:cNvSpPr/>
              <p:nvPr/>
            </p:nvSpPr>
            <p:spPr>
              <a:xfrm flipV="1">
                <a:off x="4521240" y="3482640"/>
                <a:ext cx="0" cy="293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508640" y="3483000"/>
                <a:ext cx="29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521240" y="3706560"/>
                <a:ext cx="0" cy="297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4508640" y="400356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"/>
            <p:cNvSpPr/>
            <p:nvPr/>
          </p:nvSpPr>
          <p:spPr>
            <a:xfrm>
              <a:off x="2460600" y="3089160"/>
              <a:ext cx="0" cy="1103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460600" y="4192560"/>
              <a:ext cx="2476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2460600" y="4192200"/>
              <a:ext cx="0" cy="1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4937040" y="4192200"/>
              <a:ext cx="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1144800" y="3458520"/>
              <a:ext cx="18637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Relative expression (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</a:rPr>
                <a:t>-∆∆C</a:t>
              </a:r>
              <a:r>
                <a:rPr b="0" lang="en-GB" sz="1000" spc="-1" strike="noStrike" baseline="-25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303280" y="6153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214000" y="59119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214000" y="56545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214000" y="54212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214000" y="51879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8750600">
              <a:off x="2428200" y="633348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Roo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8750600">
              <a:off x="2898720" y="634356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Stem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8722400">
              <a:off x="2882520" y="6580440"/>
              <a:ext cx="997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Vegetative leav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750600">
              <a:off x="3521160" y="6517080"/>
              <a:ext cx="828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Cauline leav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449440" y="5145120"/>
              <a:ext cx="2484360" cy="1093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449440" y="5145120"/>
              <a:ext cx="2484360" cy="10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595600" y="5994360"/>
              <a:ext cx="200160" cy="2444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094200" y="5532480"/>
              <a:ext cx="196560" cy="7063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589200" y="5638680"/>
              <a:ext cx="200160" cy="6001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087800" y="5815080"/>
              <a:ext cx="196920" cy="4237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583160" y="5937120"/>
              <a:ext cx="198360" cy="30168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693880" y="5994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676600" y="5994360"/>
              <a:ext cx="381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693880" y="5994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676600" y="5994360"/>
              <a:ext cx="381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"/>
            <p:cNvGrpSpPr/>
            <p:nvPr/>
          </p:nvGrpSpPr>
          <p:grpSpPr>
            <a:xfrm>
              <a:off x="3174840" y="5225760"/>
              <a:ext cx="36720" cy="609840"/>
              <a:chOff x="3174840" y="5225760"/>
              <a:chExt cx="36720" cy="609840"/>
            </a:xfrm>
          </p:grpSpPr>
          <p:sp>
            <p:nvSpPr>
              <p:cNvPr id="104" name=""/>
              <p:cNvSpPr/>
              <p:nvPr/>
            </p:nvSpPr>
            <p:spPr>
              <a:xfrm flipV="1">
                <a:off x="3192480" y="5225760"/>
                <a:ext cx="0" cy="30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174840" y="522612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192480" y="5532480"/>
                <a:ext cx="0" cy="30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174840" y="583560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8" name=""/>
            <p:cNvGrpSpPr/>
            <p:nvPr/>
          </p:nvGrpSpPr>
          <p:grpSpPr>
            <a:xfrm>
              <a:off x="3672000" y="5519880"/>
              <a:ext cx="36360" cy="233280"/>
              <a:chOff x="3672000" y="5519880"/>
              <a:chExt cx="36360" cy="233280"/>
            </a:xfrm>
          </p:grpSpPr>
          <p:sp>
            <p:nvSpPr>
              <p:cNvPr id="109" name=""/>
              <p:cNvSpPr/>
              <p:nvPr/>
            </p:nvSpPr>
            <p:spPr>
              <a:xfrm flipV="1">
                <a:off x="3686040" y="5519880"/>
                <a:ext cx="0" cy="11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672000" y="551988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686040" y="5638680"/>
                <a:ext cx="0" cy="11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672000" y="575316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3" name=""/>
            <p:cNvGrpSpPr/>
            <p:nvPr/>
          </p:nvGrpSpPr>
          <p:grpSpPr>
            <a:xfrm>
              <a:off x="4168800" y="5745240"/>
              <a:ext cx="36360" cy="139680"/>
              <a:chOff x="4168800" y="5745240"/>
              <a:chExt cx="36360" cy="139680"/>
            </a:xfrm>
          </p:grpSpPr>
          <p:sp>
            <p:nvSpPr>
              <p:cNvPr id="114" name=""/>
              <p:cNvSpPr/>
              <p:nvPr/>
            </p:nvSpPr>
            <p:spPr>
              <a:xfrm flipV="1">
                <a:off x="4186080" y="5745240"/>
                <a:ext cx="0" cy="69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4168800" y="574524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186080" y="5815080"/>
                <a:ext cx="0" cy="69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168800" y="588492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"/>
            <p:cNvGrpSpPr/>
            <p:nvPr/>
          </p:nvGrpSpPr>
          <p:grpSpPr>
            <a:xfrm>
              <a:off x="4664160" y="5835600"/>
              <a:ext cx="36360" cy="203400"/>
              <a:chOff x="4664160" y="5835600"/>
              <a:chExt cx="36360" cy="203400"/>
            </a:xfrm>
          </p:grpSpPr>
          <p:sp>
            <p:nvSpPr>
              <p:cNvPr id="119" name=""/>
              <p:cNvSpPr/>
              <p:nvPr/>
            </p:nvSpPr>
            <p:spPr>
              <a:xfrm flipV="1">
                <a:off x="4680000" y="5835600"/>
                <a:ext cx="0" cy="101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664160" y="583560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680000" y="5937120"/>
                <a:ext cx="0" cy="10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664160" y="603900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3" name=""/>
            <p:cNvSpPr/>
            <p:nvPr/>
          </p:nvSpPr>
          <p:spPr>
            <a:xfrm>
              <a:off x="2449440" y="5145120"/>
              <a:ext cx="0" cy="109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427120" y="623880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427120" y="611676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427120" y="599436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427120" y="587700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427120" y="575316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427120" y="563076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427120" y="550872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427120" y="539100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427120" y="526716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427120" y="514512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449440" y="6238800"/>
              <a:ext cx="2484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44944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294624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344160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flipV="1">
              <a:off x="394020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443556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4933800" y="6238800"/>
              <a:ext cx="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6200000">
              <a:off x="1132200" y="5499000"/>
              <a:ext cx="18986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Relative expression (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</a:rPr>
                <a:t>-∆∆C</a:t>
              </a:r>
              <a:r>
                <a:rPr b="0" lang="en-GB" sz="1000" spc="-1" strike="noStrike" baseline="-25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225160" y="3013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3" name=""/>
            <p:cNvGrpSpPr/>
            <p:nvPr/>
          </p:nvGrpSpPr>
          <p:grpSpPr>
            <a:xfrm>
              <a:off x="4284720" y="3144960"/>
              <a:ext cx="595080" cy="161640"/>
              <a:chOff x="4284720" y="3144960"/>
              <a:chExt cx="595080" cy="161640"/>
            </a:xfrm>
          </p:grpSpPr>
          <p:sp>
            <p:nvSpPr>
              <p:cNvPr id="144" name=""/>
              <p:cNvSpPr/>
              <p:nvPr/>
            </p:nvSpPr>
            <p:spPr>
              <a:xfrm>
                <a:off x="4284720" y="3144960"/>
                <a:ext cx="595080" cy="161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363920" y="3192120"/>
                <a:ext cx="70920" cy="6948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4479840" y="315072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</a:rPr>
                  <a:t>MDA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7" name=""/>
            <p:cNvSpPr/>
            <p:nvPr/>
          </p:nvSpPr>
          <p:spPr>
            <a:xfrm>
              <a:off x="1938600" y="25034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920960" y="45608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9" name=""/>
            <p:cNvGrpSpPr/>
            <p:nvPr/>
          </p:nvGrpSpPr>
          <p:grpSpPr>
            <a:xfrm>
              <a:off x="4284720" y="5205240"/>
              <a:ext cx="595080" cy="162000"/>
              <a:chOff x="4284720" y="5205240"/>
              <a:chExt cx="595080" cy="162000"/>
            </a:xfrm>
          </p:grpSpPr>
          <p:sp>
            <p:nvSpPr>
              <p:cNvPr id="150" name=""/>
              <p:cNvSpPr/>
              <p:nvPr/>
            </p:nvSpPr>
            <p:spPr>
              <a:xfrm>
                <a:off x="4284720" y="5205240"/>
                <a:ext cx="595080" cy="162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363920" y="5252760"/>
                <a:ext cx="70920" cy="6984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479840" y="521136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</a:rPr>
                  <a:t>MDA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3T10:15:28Z</dcterms:created>
  <dc:creator>vquesada</dc:creator>
  <dc:description/>
  <dc:language>en-US</dc:language>
  <cp:lastModifiedBy>vquesada</cp:lastModifiedBy>
  <dcterms:modified xsi:type="dcterms:W3CDTF">2012-04-24T14:33:44Z</dcterms:modified>
  <cp:revision>6</cp:revision>
  <dc:subject/>
  <dc:title>Diapositiva 1</dc:title>
</cp:coreProperties>
</file>